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3/05/2022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113249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3/05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0984" y="6050826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00" dirty="0"/>
              <a:t>Bonnefond and Semple (2022) Diabetologia DOI 10.1007/s00125-022-05720-7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enes linked with monogenic insulin-deficient diabetes encode proteins that play a key role in pancreatic beta cells</a:t>
            </a:r>
            <a:endParaRPr lang="en-GB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A65A2A9-1D9D-40F3-80E6-8226624B74B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59631" y="837669"/>
            <a:ext cx="6624737" cy="51826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6041070"/>
            <a:ext cx="7128792" cy="723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700" dirty="0"/>
              <a:t>Bonnefond and Semple (2022) Diabetologia DOI 10.1007/s00125-022-05720-7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3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204807"/>
            <a:ext cx="748883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onogenic insulin resistance subtypes and therapeutic strategies: (</a:t>
            </a:r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clustering of severe insulin resistance subtypes according to severity of insulin resistance and lipotoxic features; (</a:t>
            </a:r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genes implicated in monogenic severe insulin resistance of different subtypes and potential therapeutic strategi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36608A0-AB3F-02B7-0A6E-379FF11027E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2961" y="1916832"/>
            <a:ext cx="3478999" cy="264146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7A4204D-1BC0-1E57-6703-2ECE8146581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08064" y="1681012"/>
            <a:ext cx="3802975" cy="4220437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3</Words>
  <Application>Microsoft Office PowerPoint</Application>
  <PresentationFormat>On-screen Show (4:3)</PresentationFormat>
  <Paragraphs>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2</cp:revision>
  <dcterms:created xsi:type="dcterms:W3CDTF">2016-06-15T12:53:43Z</dcterms:created>
  <dcterms:modified xsi:type="dcterms:W3CDTF">2022-05-23T09:13:09Z</dcterms:modified>
</cp:coreProperties>
</file>